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694"/>
  </p:normalViewPr>
  <p:slideViewPr>
    <p:cSldViewPr snapToGrid="0">
      <p:cViewPr varScale="1">
        <p:scale>
          <a:sx n="121" d="100"/>
          <a:sy n="121" d="100"/>
        </p:scale>
        <p:origin x="74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1F4153-E685-B64D-06DB-2FD976AD44C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168282C-F312-BDFB-4E77-19AF035C04C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62EB187-E0DE-25FF-6AEC-D22DC053E7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94516-20A6-994A-A892-39B9BE774E42}" type="datetimeFigureOut">
              <a:rPr lang="en-US" smtClean="0"/>
              <a:t>4/23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F92AE6C-EEED-9679-B91E-578871DE2E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96B32F6-FFBE-3107-142A-3AF6732BF1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71D826-70EE-C940-9D98-A822FF5B57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19929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DCE79B-E1B8-2195-66BC-9CE8B06E844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4301948-E196-A209-7893-8BE1CE34305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D0A702B-B5F3-61C0-8DA8-297B86D04C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94516-20A6-994A-A892-39B9BE774E42}" type="datetimeFigureOut">
              <a:rPr lang="en-US" smtClean="0"/>
              <a:t>4/23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1E4D2C6-FE60-4324-9BEE-98B3E9C330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87A6EA0-3861-1678-F64C-5B18A25BF2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71D826-70EE-C940-9D98-A822FF5B57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72342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CD59FF9-4DF7-60F5-CA9F-D64E5E78628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A03EAD5-16E3-ECF8-A82B-743B79E5359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198349E-E7F9-1474-1919-EBA14F03C4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94516-20A6-994A-A892-39B9BE774E42}" type="datetimeFigureOut">
              <a:rPr lang="en-US" smtClean="0"/>
              <a:t>4/23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7EE108F-FDE4-25E1-0F4F-7FCD1E9B61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CB586FA-81B7-6087-D897-95EB6FCDB8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71D826-70EE-C940-9D98-A822FF5B57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98339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C2B290-F223-E4B1-5D65-1F6C08A590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3C696D7-0B55-0FAF-656D-0EA78D7DFB5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10593F4-A8ED-3DFC-966E-5A69E5BED9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94516-20A6-994A-A892-39B9BE774E42}" type="datetimeFigureOut">
              <a:rPr lang="en-US" smtClean="0"/>
              <a:t>4/23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B6839DB-686F-806C-B94C-83DBDC5DD3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05FA5B7-38AA-17FD-563B-36AD7A8307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71D826-70EE-C940-9D98-A822FF5B57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85922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E7E0ED-6DB1-5769-EF2A-4302D7BF03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29584BB-5EDD-3497-D9B8-A3D8D08B2D6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05AB30A-03FF-22DC-B228-E5747C549F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94516-20A6-994A-A892-39B9BE774E42}" type="datetimeFigureOut">
              <a:rPr lang="en-US" smtClean="0"/>
              <a:t>4/23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F56C983-E285-2F01-BE39-6640A9C299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C1D2D37-0655-4CC0-F50F-7C6815F0A7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71D826-70EE-C940-9D98-A822FF5B57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90244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4B2C61-9B12-751E-BA4F-7B0E9659D8D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946000A-C033-260E-27A3-AAF8783E56A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F353FA4-A6A8-FB9C-4D0C-6955FDE19D1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57B8B31-686D-76CE-EDCD-5B8FBA92E6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94516-20A6-994A-A892-39B9BE774E42}" type="datetimeFigureOut">
              <a:rPr lang="en-US" smtClean="0"/>
              <a:t>4/23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1D21F5C-13FC-86FD-A88A-375764FE56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9D64436-C700-2E88-8F01-1D30CE0339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71D826-70EE-C940-9D98-A822FF5B57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33889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97FDC9-4ED9-E097-7324-C74545DBCD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AEF6697-B816-AAC4-0C4C-92409296979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9D7BA5B-0D30-E977-4173-BBF73CB1A21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91DB4CD-496F-747E-2696-539B5B2FDA9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3BD01E6-23E1-C2DD-0893-757A650E49B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89B971B-C33E-3322-7395-98C1F910AD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94516-20A6-994A-A892-39B9BE774E42}" type="datetimeFigureOut">
              <a:rPr lang="en-US" smtClean="0"/>
              <a:t>4/23/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FF8CAFA-91FC-4673-EE27-6332DBD1B2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1363BE1-270A-ADE0-66D3-A56A587185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71D826-70EE-C940-9D98-A822FF5B57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83935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3A2A60F-AEA0-2A57-86D1-2C638DD56A2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2FCB228-6720-A826-AE1F-44E478CAD9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94516-20A6-994A-A892-39B9BE774E42}" type="datetimeFigureOut">
              <a:rPr lang="en-US" smtClean="0"/>
              <a:t>4/23/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502851B-AD94-30DF-4600-C4954C9CBD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5F613EC-3FE0-C2B6-F452-D32A8149D1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71D826-70EE-C940-9D98-A822FF5B57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75822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636FB77-84B6-3A47-31BD-D29DE65047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94516-20A6-994A-A892-39B9BE774E42}" type="datetimeFigureOut">
              <a:rPr lang="en-US" smtClean="0"/>
              <a:t>4/23/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82731A4-C457-8327-F356-7B7F2EC914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093C995-979F-8723-EC13-2252008AE7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71D826-70EE-C940-9D98-A822FF5B57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81600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D1CABB1-EBBF-0CCB-C651-776384E982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5DCFF84-2D4E-5A78-0C46-70BA0CC7C3B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50870FA-E5D9-4DBF-352F-FE2E9C8D414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8DB7B74-B7A2-A292-2B64-7BDC02EC2A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94516-20A6-994A-A892-39B9BE774E42}" type="datetimeFigureOut">
              <a:rPr lang="en-US" smtClean="0"/>
              <a:t>4/23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AD5353B-F14D-E0B9-2E17-80966DA582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ADC874D-F0D9-4520-ED4E-D0F5887345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71D826-70EE-C940-9D98-A822FF5B57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76278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37DE43E-F5FD-1FD9-16FB-F3C93FF1847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AF504CE-F68B-D4B6-2F2F-82351188A80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D18F582-ABA5-925A-03A8-83069563CB6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3E9F98A-7A18-AA66-0091-CDB8E87F97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94516-20A6-994A-A892-39B9BE774E42}" type="datetimeFigureOut">
              <a:rPr lang="en-US" smtClean="0"/>
              <a:t>4/23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5D4C40D-47EB-FC46-2DAB-2235FA7CEB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37F974A-E91F-E6CB-BD42-99CDF4611A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71D826-70EE-C940-9D98-A822FF5B57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2702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FA72B05-D92A-1609-D4CE-C0C1075DF5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1B63292-F2B9-FA70-DA1F-66C7843DE44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6CB7507-C8FC-FA06-C91A-100ACFF09A1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0094516-20A6-994A-A892-39B9BE774E42}" type="datetimeFigureOut">
              <a:rPr lang="en-US" smtClean="0"/>
              <a:t>4/23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2EAB4ED-2B47-EB6E-920A-EBABBB77B6E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5F080A9-EEE5-6F80-256C-64B04D5DFB1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171D826-70EE-C940-9D98-A822FF5B57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38137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EC54744F-09F5-72FD-8008-8FD0DE5A138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11445" y="1834523"/>
            <a:ext cx="5769108" cy="3188954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0BCEF7BF-2B82-BBDD-AEB1-DDA3A5C71120}"/>
              </a:ext>
            </a:extLst>
          </p:cNvPr>
          <p:cNvSpPr txBox="1"/>
          <p:nvPr/>
        </p:nvSpPr>
        <p:spPr>
          <a:xfrm>
            <a:off x="0" y="6517927"/>
            <a:ext cx="12191999" cy="255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9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1. The editing efficiency of ts-SeV-Cas9 </a:t>
            </a:r>
            <a:r>
              <a:rPr lang="en-US" sz="1059" b="1" dirty="0" err="1">
                <a:latin typeface="Arial" panose="020B0604020202020204" pitchFamily="34" charset="0"/>
                <a:cs typeface="Arial" panose="020B0604020202020204" pitchFamily="34" charset="0"/>
              </a:rPr>
              <a:t>mCherry</a:t>
            </a:r>
            <a:r>
              <a:rPr lang="en-US" sz="1059" b="1" dirty="0">
                <a:latin typeface="Arial" panose="020B0604020202020204" pitchFamily="34" charset="0"/>
                <a:cs typeface="Arial" panose="020B0604020202020204" pitchFamily="34" charset="0"/>
              </a:rPr>
              <a:t> in CD34+ HSCs. </a:t>
            </a:r>
            <a:r>
              <a:rPr lang="en-US" sz="1059" dirty="0">
                <a:latin typeface="Arial" panose="020B0604020202020204" pitchFamily="34" charset="0"/>
                <a:cs typeface="Arial" panose="020B0604020202020204" pitchFamily="34" charset="0"/>
              </a:rPr>
              <a:t>Indel frequency calculated as described in Figure 3B. </a:t>
            </a:r>
          </a:p>
        </p:txBody>
      </p:sp>
    </p:spTree>
    <p:extLst>
      <p:ext uri="{BB962C8B-B14F-4D97-AF65-F5344CB8AC3E}">
        <p14:creationId xmlns:p14="http://schemas.microsoft.com/office/powerpoint/2010/main" val="745288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2">
            <a:extLst>
              <a:ext uri="{FF2B5EF4-FFF2-40B4-BE49-F238E27FC236}">
                <a16:creationId xmlns:a16="http://schemas.microsoft.com/office/drawing/2014/main" id="{0CCD6923-8E08-B1B4-F1BE-9AEAFA8B293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41577749"/>
              </p:ext>
            </p:extLst>
          </p:nvPr>
        </p:nvGraphicFramePr>
        <p:xfrm>
          <a:off x="2115206" y="1074683"/>
          <a:ext cx="7805729" cy="42640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2" imgW="5849684" imgH="3195647" progId="Prism6.Document">
                  <p:embed/>
                </p:oleObj>
              </mc:Choice>
              <mc:Fallback>
                <p:oleObj name="Prism 6" r:id="rId2" imgW="5849684" imgH="3195647" progId="Prism6.Document">
                  <p:embed/>
                  <p:pic>
                    <p:nvPicPr>
                      <p:cNvPr id="16386" name="Object 2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3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115206" y="1074683"/>
                        <a:ext cx="7805729" cy="426402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 xmlns="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xmlns="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 xmlns="">
                            <a:effectLst>
                              <a:outerShdw blurRad="63500" dist="38099" dir="2700000" algn="ctr" rotWithShape="0">
                                <a:schemeClr val="bg2">
                                  <a:alpha val="74998"/>
                                </a:schemeClr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D4ED0B77-D946-B957-E351-BB473628719F}"/>
              </a:ext>
            </a:extLst>
          </p:cNvPr>
          <p:cNvSpPr txBox="1"/>
          <p:nvPr/>
        </p:nvSpPr>
        <p:spPr>
          <a:xfrm>
            <a:off x="0" y="6517927"/>
            <a:ext cx="12191999" cy="255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9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2. The effect on hematopoietic differentiation of CD34+ HSPCs following infection by </a:t>
            </a:r>
            <a:r>
              <a:rPr lang="en-US" sz="1059" b="1" dirty="0" err="1">
                <a:latin typeface="Arial" panose="020B0604020202020204" pitchFamily="34" charset="0"/>
                <a:cs typeface="Arial" panose="020B0604020202020204" pitchFamily="34" charset="0"/>
              </a:rPr>
              <a:t>SeV</a:t>
            </a:r>
            <a:r>
              <a:rPr lang="en-US" sz="1059" b="1" dirty="0">
                <a:latin typeface="Arial" panose="020B0604020202020204" pitchFamily="34" charset="0"/>
                <a:cs typeface="Arial" panose="020B0604020202020204" pitchFamily="34" charset="0"/>
              </a:rPr>
              <a:t> Cas9. </a:t>
            </a:r>
            <a:r>
              <a:rPr lang="en-US" sz="1059" dirty="0">
                <a:latin typeface="Arial" panose="020B0604020202020204" pitchFamily="34" charset="0"/>
                <a:cs typeface="Arial" panose="020B0604020202020204" pitchFamily="34" charset="0"/>
              </a:rPr>
              <a:t>Raw colony counts, performed as described in Figure 5C</a:t>
            </a:r>
            <a:r>
              <a:rPr lang="en-US" sz="1059" b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US" sz="1059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812069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54</Words>
  <Application>Microsoft Macintosh PowerPoint</Application>
  <PresentationFormat>Widescreen</PresentationFormat>
  <Paragraphs>2</Paragraphs>
  <Slides>2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ptos</vt:lpstr>
      <vt:lpstr>Aptos Display</vt:lpstr>
      <vt:lpstr>Arial</vt:lpstr>
      <vt:lpstr>Office Theme</vt:lpstr>
      <vt:lpstr>Prism 6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ebecca Reis</dc:creator>
  <cp:lastModifiedBy>Rebecca Reis</cp:lastModifiedBy>
  <cp:revision>1</cp:revision>
  <dcterms:created xsi:type="dcterms:W3CDTF">2024-04-23T21:49:01Z</dcterms:created>
  <dcterms:modified xsi:type="dcterms:W3CDTF">2024-04-23T21:52:43Z</dcterms:modified>
</cp:coreProperties>
</file>